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84E427A-3D55-4303-BF80-6455036E1DE7}" styleName="テーマ スタイル 1 - アクセント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27102A9-8310-4765-A935-A1911B00CA55}" styleName="淡色スタイル 1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43"/>
    <p:restoredTop sz="94631"/>
  </p:normalViewPr>
  <p:slideViewPr>
    <p:cSldViewPr snapToGrid="0" snapToObjects="1">
      <p:cViewPr varScale="1">
        <p:scale>
          <a:sx n="70" d="100"/>
          <a:sy n="70" d="100"/>
        </p:scale>
        <p:origin x="5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AFEDCEE-B928-7949-B30A-46ADE7255E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ADEA46CB-A0BC-6340-B6B1-42174B3CA6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708CB5B-5561-F442-8E9C-A5CE36977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49310C5-C380-4D47-8A2F-2A8740D0A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1761322-CD39-C140-8F75-855F15E69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490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261A963-2F61-F24A-ABA3-8487CE5FF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5F97B66D-6EE5-E248-9A6C-2516DCB7EF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CDFBCEA-B233-C143-80EA-91C4E73CE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9CFFF5E-4DCD-564D-B6BF-E1B6E87CB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879226E-8BD6-194F-AF01-6BC33F971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9753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51C8919E-22C6-1D47-9F06-EF2A07EB84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47846E1-3F47-B947-A2FA-2AB9EF02F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0B48BC6-5AF8-B04C-819D-3DE57176D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4C7BEBC-2905-1B47-8B03-9DE5D46BF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E3AC532-8BD5-2B47-BCAA-6C98DD1B1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985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91E318E-F136-5D48-B038-A2A46252E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6348AA0-38D7-904D-99C4-A26A6912AB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AB3306A-3561-9848-8618-464F0D2051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97849AC-7711-FC45-BB3B-CD0365E05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073C194-73CA-8A48-911E-728A9979D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325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23C1562-E682-A14E-AECA-C0BF9BC26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3952F143-AECC-4D4B-A8F5-B481601BF1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91CA206-862C-8441-AEB5-81F985241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82ED5D8-7300-2241-AFB0-7360EAC59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EFA15D1-8E93-844F-98BF-298423B0D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685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1838D9D-2702-C14B-9FBE-9964227BD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5DDF090-2986-B949-984F-B302E405B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8FB44D8D-8F5E-4044-98CF-F2852AD909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DBE9570-88F4-C54A-A126-6C3868259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484F8F7-5D59-C541-95D8-D08825579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90BC373A-8D92-4544-B102-88DADEE78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7918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B197BBC-C92F-E948-9FBD-30AE84453F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E71B22C9-543C-CB43-B712-BDAB952289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E846DB80-7F64-7E41-8C76-677E17AD3C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B9F8891F-7C3C-004C-BF9A-2F325D1497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07EACCE8-AFAA-E545-B8A4-2286E45C6B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029C1DBB-DEB4-3242-BD1E-A1DC12CBC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98CA0002-DA14-C141-BA38-D80C15C5F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D4B97E17-4066-BA4B-9058-C91E22E00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037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1657B61-7AD3-FD43-849F-72666078C7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1F4F54C5-F565-8A45-8CE0-A674706F3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C0404147-2A9C-F546-8259-9896557A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A8BB5A7A-9283-2F46-B059-1211691B9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778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FFDA07DC-7169-354E-8843-9607C1F00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A4BA581F-1AD2-F044-91D7-B0077E9CA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49000E38-7F5D-2C44-BE71-0CAFAF48B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480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C45009F-BC70-6345-898E-8BC7F29F6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FC97A42B-2BFC-4241-A1C4-2EC0B26957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2F7A647D-B778-524C-9DC6-64C1FB97BA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31CFF8D-9B0B-6D43-82C4-2E05BDAE3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463A449-8BA5-3147-9434-2A793C625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892E63C-18D2-4C4D-9F28-F7CF199BF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005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7C46ABE-5F3D-2C49-9725-9222148CA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D8D83B8A-8F58-5446-AD5C-C26CEAAB75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301D9297-A7B2-674A-BE3B-72A8BB22AC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417ED47-0D71-1A43-87D9-6E647454F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35A8D19-05DF-CD49-85FB-D3412F25E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C355956-95D5-8247-819F-588A24EF0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795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182206E7-E610-DD41-B6BA-9601C91D0F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DFFD8CAB-F8A0-1A4D-A56B-3010DAD931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3F9D970-BFD2-8047-9394-0897FA7308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FA32D-E7DC-8046-B5FE-C73E6138F7BF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B4F8693-161D-BA49-B936-53165B8A12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1A6E06D-5C90-9C4C-977E-64C1C8105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8F9E2-9543-E540-9EB5-DB0CC6FCA9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0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xmlns="" id="{52AAA4A2-EC81-1D45-98FB-45DB695308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377075"/>
              </p:ext>
            </p:extLst>
          </p:nvPr>
        </p:nvGraphicFramePr>
        <p:xfrm>
          <a:off x="151083" y="-28576"/>
          <a:ext cx="11858019" cy="66484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84175">
                  <a:extLst>
                    <a:ext uri="{9D8B030D-6E8A-4147-A177-3AD203B41FA5}">
                      <a16:colId xmlns:a16="http://schemas.microsoft.com/office/drawing/2014/main" xmlns="" val="3397124929"/>
                    </a:ext>
                  </a:extLst>
                </a:gridCol>
                <a:gridCol w="558921">
                  <a:extLst>
                    <a:ext uri="{9D8B030D-6E8A-4147-A177-3AD203B41FA5}">
                      <a16:colId xmlns:a16="http://schemas.microsoft.com/office/drawing/2014/main" xmlns="" val="2200713463"/>
                    </a:ext>
                  </a:extLst>
                </a:gridCol>
                <a:gridCol w="1809432">
                  <a:extLst>
                    <a:ext uri="{9D8B030D-6E8A-4147-A177-3AD203B41FA5}">
                      <a16:colId xmlns:a16="http://schemas.microsoft.com/office/drawing/2014/main" xmlns="" val="1420453147"/>
                    </a:ext>
                  </a:extLst>
                </a:gridCol>
                <a:gridCol w="126457">
                  <a:extLst>
                    <a:ext uri="{9D8B030D-6E8A-4147-A177-3AD203B41FA5}">
                      <a16:colId xmlns:a16="http://schemas.microsoft.com/office/drawing/2014/main" xmlns="" val="1100721943"/>
                    </a:ext>
                  </a:extLst>
                </a:gridCol>
                <a:gridCol w="1073984">
                  <a:extLst>
                    <a:ext uri="{9D8B030D-6E8A-4147-A177-3AD203B41FA5}">
                      <a16:colId xmlns:a16="http://schemas.microsoft.com/office/drawing/2014/main" xmlns="" val="3900472281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3420216328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3279851858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2932230885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4289705622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2150840220"/>
                    </a:ext>
                  </a:extLst>
                </a:gridCol>
                <a:gridCol w="1184175">
                  <a:extLst>
                    <a:ext uri="{9D8B030D-6E8A-4147-A177-3AD203B41FA5}">
                      <a16:colId xmlns:a16="http://schemas.microsoft.com/office/drawing/2014/main" xmlns="" val="2704658579"/>
                    </a:ext>
                  </a:extLst>
                </a:gridCol>
              </a:tblGrid>
              <a:tr h="184137">
                <a:tc gridSpan="1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pplemental </a:t>
                      </a:r>
                      <a:r>
                        <a:rPr kumimoji="1" lang="en-US" altLang="ja-JP" sz="900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ble 1.</a:t>
                      </a:r>
                      <a:endParaRPr kumimoji="1" lang="ja-JP" altLang="ja-JP" sz="900" kern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1737994"/>
                  </a:ext>
                </a:extLst>
              </a:tr>
              <a:tr h="184137">
                <a:tc gridSpan="1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verage age and weight of all mice relative to each experimental result.</a:t>
                      </a:r>
                      <a:endParaRPr kumimoji="1" lang="ja-JP" altLang="ja-JP" sz="90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75474846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age (weeks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 limitation 95%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limitation 95%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key-Kramer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’s </a:t>
                      </a:r>
                      <a:r>
                        <a:rPr kumimoji="1" lang="en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est (</a:t>
                      </a:r>
                      <a:r>
                        <a:rPr kumimoji="1" lang="en-US" altLang="ja-JP" sz="9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weight (g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 limitation 95%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limitation 95%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key-Kramer’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 </a:t>
                      </a:r>
                      <a:r>
                        <a:rPr kumimoji="1" lang="en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st (</a:t>
                      </a:r>
                      <a:r>
                        <a:rPr kumimoji="1" lang="en-US" altLang="ja-JP" sz="9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62529940"/>
                  </a:ext>
                </a:extLst>
              </a:tr>
              <a:tr h="184137">
                <a:tc gridSpan="10"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orescence intensity in the interstitial space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14918167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52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7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7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4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6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.8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3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298112749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3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7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7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4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8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79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8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8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125660592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87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3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62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6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6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600442893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14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9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9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3.8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3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.0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3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95466610"/>
                  </a:ext>
                </a:extLst>
              </a:tr>
              <a:tr h="184137">
                <a:tc gridSpan="10"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X index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77871875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84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1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6.2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0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7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8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1.2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498517941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8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kumimoji="1"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3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1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4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17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1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0.0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189977678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0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8.7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5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62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4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5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675344434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9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1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0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26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1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2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89626842"/>
                  </a:ext>
                </a:extLst>
              </a:tr>
              <a:tr h="0">
                <a:tc gridSpan="10"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ndecan-1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52611734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9.8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49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6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1.8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 0.01 vs NS-V, </a:t>
                      </a:r>
                    </a:p>
                    <a:p>
                      <a:pPr algn="ctr" rtl="0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1 vs NS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7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3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0.9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245400626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19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8.1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 0.01 vs NS-V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2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61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2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2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75465465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8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5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7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9.0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 0.01 vs NS-V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3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31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7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9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64013613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9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0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9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6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0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1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79884021"/>
                  </a:ext>
                </a:extLst>
              </a:tr>
              <a:tr h="0">
                <a:tc gridSpan="10"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 gas analysis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508116124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3.3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37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8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7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96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7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1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60774312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3.3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25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7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0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58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6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3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65077825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3.5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1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3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6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7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1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6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75495766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75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7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6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6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63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38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7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55304555"/>
                  </a:ext>
                </a:extLst>
              </a:tr>
              <a:tr h="0">
                <a:tc gridSpan="10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ve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9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day 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mulative mortality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794075210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5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6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6.19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3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7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0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61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94833308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9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5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.1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7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1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2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2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842154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7.1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4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6.06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8.14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1 </a:t>
                      </a:r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vs NS-V</a:t>
                      </a:r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, </a:t>
                      </a:r>
                    </a:p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1 vs NS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7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7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6.4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8.9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795135541"/>
                  </a:ext>
                </a:extLst>
              </a:tr>
              <a:tr h="18413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</a:t>
                      </a:r>
                      <a:endParaRPr kumimoji="1" lang="ja-JP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9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4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2.4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.67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13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5.9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1.62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4.70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7.02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.S.</a:t>
                      </a:r>
                    </a:p>
                  </a:txBody>
                  <a:tcPr marL="9525" marR="9525" marT="952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709787684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B0A2581F-1F84-6E42-991D-2E3CB095D027}"/>
              </a:ext>
            </a:extLst>
          </p:cNvPr>
          <p:cNvSpPr txBox="1"/>
          <p:nvPr/>
        </p:nvSpPr>
        <p:spPr>
          <a:xfrm>
            <a:off x="151083" y="6648450"/>
            <a:ext cx="7966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data are expressed as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± S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531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360</Words>
  <Application>Microsoft Office PowerPoint</Application>
  <PresentationFormat>ワイド画面</PresentationFormat>
  <Paragraphs>2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鵜澤康二</dc:creator>
  <cp:lastModifiedBy>tyorozu</cp:lastModifiedBy>
  <cp:revision>17</cp:revision>
  <dcterms:created xsi:type="dcterms:W3CDTF">2019-07-05T03:25:26Z</dcterms:created>
  <dcterms:modified xsi:type="dcterms:W3CDTF">2019-10-29T14:20:38Z</dcterms:modified>
</cp:coreProperties>
</file>